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99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77885C-82C3-468C-AADE-62407D12028E}" type="datetimeFigureOut">
              <a:rPr lang="en-US" smtClean="0"/>
              <a:t>7/24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27DF32-712B-4C5A-BF6A-AA341CD71F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58156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EA6661-D825-4473-93E3-38003A612014}" type="datetimeFigureOut">
              <a:rPr lang="en-US" smtClean="0"/>
              <a:t>7/2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739A3A-20D5-4744-80FE-68A518A73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8382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EA6661-D825-4473-93E3-38003A612014}" type="datetimeFigureOut">
              <a:rPr lang="en-US" smtClean="0"/>
              <a:t>7/2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739A3A-20D5-4744-80FE-68A518A73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3583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EA6661-D825-4473-93E3-38003A612014}" type="datetimeFigureOut">
              <a:rPr lang="en-US" smtClean="0"/>
              <a:t>7/2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739A3A-20D5-4744-80FE-68A518A73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597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EA6661-D825-4473-93E3-38003A612014}" type="datetimeFigureOut">
              <a:rPr lang="en-US" smtClean="0"/>
              <a:t>7/2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739A3A-20D5-4744-80FE-68A518A73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06173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EA6661-D825-4473-93E3-38003A612014}" type="datetimeFigureOut">
              <a:rPr lang="en-US" smtClean="0"/>
              <a:t>7/2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739A3A-20D5-4744-80FE-68A518A73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6480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EA6661-D825-4473-93E3-38003A612014}" type="datetimeFigureOut">
              <a:rPr lang="en-US" smtClean="0"/>
              <a:t>7/2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739A3A-20D5-4744-80FE-68A518A73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20709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EA6661-D825-4473-93E3-38003A612014}" type="datetimeFigureOut">
              <a:rPr lang="en-US" smtClean="0"/>
              <a:t>7/24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739A3A-20D5-4744-80FE-68A518A73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937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EA6661-D825-4473-93E3-38003A612014}" type="datetimeFigureOut">
              <a:rPr lang="en-US" smtClean="0"/>
              <a:t>7/24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739A3A-20D5-4744-80FE-68A518A73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28532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EA6661-D825-4473-93E3-38003A612014}" type="datetimeFigureOut">
              <a:rPr lang="en-US" smtClean="0"/>
              <a:t>7/24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739A3A-20D5-4744-80FE-68A518A73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93814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EA6661-D825-4473-93E3-38003A612014}" type="datetimeFigureOut">
              <a:rPr lang="en-US" smtClean="0"/>
              <a:t>7/2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739A3A-20D5-4744-80FE-68A518A73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2751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EA6661-D825-4473-93E3-38003A612014}" type="datetimeFigureOut">
              <a:rPr lang="en-US" smtClean="0"/>
              <a:t>7/2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739A3A-20D5-4744-80FE-68A518A73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0969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EA6661-D825-4473-93E3-38003A612014}" type="datetimeFigureOut">
              <a:rPr lang="en-US" smtClean="0"/>
              <a:t>7/2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739A3A-20D5-4744-80FE-68A518A73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19527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38830419"/>
              </p:ext>
            </p:extLst>
          </p:nvPr>
        </p:nvGraphicFramePr>
        <p:xfrm>
          <a:off x="304800" y="533397"/>
          <a:ext cx="8382000" cy="5852974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2909996"/>
                <a:gridCol w="2450586"/>
                <a:gridCol w="1345018"/>
                <a:gridCol w="1676400"/>
              </a:tblGrid>
              <a:tr h="573132"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lement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olate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42</a:t>
                      </a:r>
                    </a:p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Parent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R Time</a:t>
                      </a:r>
                      <a:r>
                        <a:rPr lang="en-US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duction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569056"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B High Performance Media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D-RB00088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.6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2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569056">
                <a:tc rowSpan="4"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BS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P1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.9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9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569056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P2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.5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1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</a:tr>
              <a:tr h="569056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H1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4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.9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</a:tr>
              <a:tr h="589422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H2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.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.3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569056">
                <a:tc rowSpan="4">
                  <a:txBody>
                    <a:bodyPr/>
                    <a:lstStyle/>
                    <a:p>
                      <a:pPr algn="ctr"/>
                      <a:r>
                        <a:rPr lang="en-US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PL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P1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.2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569056">
                <a:tc v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P2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.1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.7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</a:tr>
              <a:tr h="569056">
                <a:tc v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H1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.8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.6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</a:tr>
              <a:tr h="569056">
                <a:tc v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H2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.6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.5</a:t>
                      </a:r>
                      <a:endParaRPr 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408738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</TotalTime>
  <Words>42</Words>
  <Application>Microsoft Office PowerPoint</Application>
  <PresentationFormat>On-screen Show (4:3)</PresentationFormat>
  <Paragraphs>3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EDCO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walczewski, Andrew C</dc:creator>
  <cp:lastModifiedBy>Kowalczewski, Andrew C</cp:lastModifiedBy>
  <cp:revision>3</cp:revision>
  <dcterms:created xsi:type="dcterms:W3CDTF">2017-07-24T19:17:03Z</dcterms:created>
  <dcterms:modified xsi:type="dcterms:W3CDTF">2017-07-24T20:30:30Z</dcterms:modified>
</cp:coreProperties>
</file>